
<file path=[Content_Types].xml><?xml version="1.0" encoding="utf-8"?>
<Types xmlns="http://schemas.openxmlformats.org/package/2006/content-types">
  <Default Extension="jpeg" ContentType="image/jpeg"/>
  <Default Extension="JPG" ContentType="image/.jp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2" r:id="rId3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08" d="100"/>
          <a:sy n="108" d="100"/>
        </p:scale>
        <p:origin x="678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66AD5-5762-4997-95B2-3CC28A227D2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28346-9CF9-46D9-B41A-75F5330D8EB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66AD5-5762-4997-95B2-3CC28A227D2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28346-9CF9-46D9-B41A-75F5330D8EB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66AD5-5762-4997-95B2-3CC28A227D2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28346-9CF9-46D9-B41A-75F5330D8EB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66AD5-5762-4997-95B2-3CC28A227D2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28346-9CF9-46D9-B41A-75F5330D8EB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66AD5-5762-4997-95B2-3CC28A227D2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28346-9CF9-46D9-B41A-75F5330D8EB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66AD5-5762-4997-95B2-3CC28A227D2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28346-9CF9-46D9-B41A-75F5330D8EB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66AD5-5762-4997-95B2-3CC28A227D25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28346-9CF9-46D9-B41A-75F5330D8EB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66AD5-5762-4997-95B2-3CC28A227D25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28346-9CF9-46D9-B41A-75F5330D8EB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66AD5-5762-4997-95B2-3CC28A227D25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28346-9CF9-46D9-B41A-75F5330D8EB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66AD5-5762-4997-95B2-3CC28A227D2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28346-9CF9-46D9-B41A-75F5330D8EB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666AD5-5762-4997-95B2-3CC28A227D25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6428346-9CF9-46D9-B41A-75F5330D8EB4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二级</a:t>
            </a:r>
            <a:endParaRPr lang="zh-CN" altLang="en-US"/>
          </a:p>
          <a:p>
            <a:pPr lvl="2"/>
            <a:r>
              <a:rPr lang="zh-CN" altLang="en-US"/>
              <a:t>三级</a:t>
            </a:r>
            <a:endParaRPr lang="zh-CN" altLang="en-US"/>
          </a:p>
          <a:p>
            <a:pPr lvl="3"/>
            <a:r>
              <a:rPr lang="zh-CN" altLang="en-US"/>
              <a:t>四级</a:t>
            </a:r>
            <a:endParaRPr lang="zh-CN" altLang="en-US"/>
          </a:p>
          <a:p>
            <a:pPr lvl="4"/>
            <a:r>
              <a:rPr lang="zh-CN" altLang="en-US"/>
              <a:t>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666AD5-5762-4997-95B2-3CC28A227D25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428346-9CF9-46D9-B41A-75F5330D8EB4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9" name="表格 9"/>
          <p:cNvGraphicFramePr>
            <a:graphicFrameLocks noGrp="1"/>
          </p:cNvGraphicFramePr>
          <p:nvPr/>
        </p:nvGraphicFramePr>
        <p:xfrm>
          <a:off x="3149480" y="1563044"/>
          <a:ext cx="4871865" cy="3626832"/>
        </p:xfrm>
        <a:graphic>
          <a:graphicData uri="http://schemas.openxmlformats.org/drawingml/2006/table">
            <a:tbl>
              <a:tblPr firstRow="1" bandRow="1">
                <a:tableStyleId>{5940675A-B579-460E-94D1-54222C63F5DA}</a:tableStyleId>
              </a:tblPr>
              <a:tblGrid>
                <a:gridCol w="1084062"/>
                <a:gridCol w="1873188"/>
                <a:gridCol w="1914615"/>
              </a:tblGrid>
              <a:tr h="1037281"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2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ample</a:t>
                      </a:r>
                      <a:endParaRPr lang="zh-CN" altLang="en-US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endParaRPr lang="zh-CN" altLang="en-US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2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defRPr/>
                      </a:pPr>
                      <a:r>
                        <a:rPr lang="en-US" altLang="zh-CN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Tensile Strength</a:t>
                      </a:r>
                      <a:endParaRPr lang="zh-CN" altLang="en-US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/>
                      <a:endParaRPr lang="zh-CN" altLang="en-US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50000"/>
                        </a:lnSpc>
                      </a:pPr>
                      <a:r>
                        <a:rPr lang="en-US" altLang="zh-CN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hore Hardness</a:t>
                      </a:r>
                      <a:endParaRPr lang="zh-CN" altLang="en-US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822864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</a:t>
                      </a:r>
                      <a:endParaRPr lang="zh-CN" altLang="en-US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50psi</a:t>
                      </a:r>
                      <a:endParaRPr lang="zh-CN" altLang="en-US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A</a:t>
                      </a:r>
                      <a:endParaRPr lang="zh-CN" altLang="en-US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822864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</a:t>
                      </a:r>
                      <a:endParaRPr lang="zh-CN" altLang="en-US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75psi</a:t>
                      </a:r>
                      <a:endParaRPr lang="zh-CN" altLang="en-US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A</a:t>
                      </a:r>
                      <a:endParaRPr lang="zh-CN" altLang="en-US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  <a:tr h="822864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</a:t>
                      </a:r>
                      <a:endParaRPr lang="zh-CN" altLang="en-US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50psi</a:t>
                      </a:r>
                      <a:endParaRPr lang="zh-CN" altLang="en-US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</a:pPr>
                      <a:r>
                        <a:rPr lang="en-US" altLang="zh-CN" sz="2000" dirty="0"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A</a:t>
                      </a:r>
                      <a:endParaRPr lang="zh-CN" altLang="en-US" sz="200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</a:tcPr>
                </a:tc>
              </a:tr>
            </a:tbl>
          </a:graphicData>
        </a:graphic>
      </p:graphicFrame>
      <p:sp>
        <p:nvSpPr>
          <p:cNvPr id="10" name="文本框 9"/>
          <p:cNvSpPr txBox="1"/>
          <p:nvPr/>
        </p:nvSpPr>
        <p:spPr>
          <a:xfrm>
            <a:off x="3143677" y="1152685"/>
            <a:ext cx="4964646" cy="33718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defRPr/>
            </a:pP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Table </a:t>
            </a:r>
            <a:r>
              <a:rPr kumimoji="0" lang="en-US" altLang="zh-CN" sz="1600" b="1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Times New Roman" panose="02020603050405020304" pitchFamily="18" charset="0"/>
                <a:ea typeface="微软雅黑" panose="020B0503020204020204" pitchFamily="34" charset="-122"/>
                <a:cs typeface="Times New Roman" panose="02020603050405020304" pitchFamily="18" charset="0"/>
              </a:rPr>
              <a:t>S1: Three silicone joint for experimental study</a:t>
            </a:r>
            <a:endParaRPr kumimoji="0" lang="zh-CN" altLang="en-US" sz="1600" b="1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Times New Roman" panose="02020603050405020304" pitchFamily="18" charset="0"/>
              <a:ea typeface="微软雅黑" panose="020B0503020204020204" pitchFamily="34" charset="-122"/>
              <a:cs typeface="Times New Roman" panose="02020603050405020304" pitchFamily="18" charset="0"/>
            </a:endParaRPr>
          </a:p>
        </p:txBody>
      </p:sp>
      <p:cxnSp>
        <p:nvCxnSpPr>
          <p:cNvPr id="3" name="直接连接符 2"/>
          <p:cNvCxnSpPr/>
          <p:nvPr/>
        </p:nvCxnSpPr>
        <p:spPr>
          <a:xfrm>
            <a:off x="3294973" y="1571342"/>
            <a:ext cx="465189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直接连接符 15"/>
          <p:cNvCxnSpPr/>
          <p:nvPr/>
        </p:nvCxnSpPr>
        <p:spPr>
          <a:xfrm>
            <a:off x="3277217" y="5177169"/>
            <a:ext cx="4651899" cy="0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连接符 17"/>
          <p:cNvCxnSpPr/>
          <p:nvPr/>
        </p:nvCxnSpPr>
        <p:spPr>
          <a:xfrm>
            <a:off x="3294973" y="2709172"/>
            <a:ext cx="4651899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8</Words>
  <Application>WPS 演示</Application>
  <PresentationFormat>宽屏</PresentationFormat>
  <Paragraphs>28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9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1" baseType="lpstr">
      <vt:lpstr>Arial</vt:lpstr>
      <vt:lpstr>宋体</vt:lpstr>
      <vt:lpstr>Wingdings</vt:lpstr>
      <vt:lpstr>Times New Roman</vt:lpstr>
      <vt:lpstr>微软雅黑</vt:lpstr>
      <vt:lpstr>Arial Unicode MS</vt:lpstr>
      <vt:lpstr>等线 Light</vt:lpstr>
      <vt:lpstr>等线</vt:lpstr>
      <vt:lpstr>Calibri</vt:lpstr>
      <vt:lpstr>Office 主题​​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xu</dc:creator>
  <cp:lastModifiedBy>陶金</cp:lastModifiedBy>
  <cp:revision>2</cp:revision>
  <dcterms:created xsi:type="dcterms:W3CDTF">2021-06-08T12:54:00Z</dcterms:created>
  <dcterms:modified xsi:type="dcterms:W3CDTF">2021-06-08T13:00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D2480E6F77F2418F8E436926081041A1</vt:lpwstr>
  </property>
  <property fmtid="{D5CDD505-2E9C-101B-9397-08002B2CF9AE}" pid="3" name="KSOProductBuildVer">
    <vt:lpwstr>2052-11.1.0.10577</vt:lpwstr>
  </property>
</Properties>
</file>